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3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ng.ling\Desktop\20171013%20KUMC%20RNA%20expression%20work\KUMC%20standard%20curves\BUTLERLAB%20%206.12.18%20results%20and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ng.ling\Desktop\20171013%20KUMC%20RNA%20expression%20work\KUMC%20standard%20curves\BUTLERLAB%20%206.12.18%20results%20and%20graph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esults and graphs'!$C$2</c:f>
              <c:strCache>
                <c:ptCount val="1"/>
                <c:pt idx="0">
                  <c:v>SNRPN</c:v>
                </c:pt>
              </c:strCache>
            </c:strRef>
          </c:tx>
          <c:spPr>
            <a:ln w="25400" cap="flat" cmpd="sng" algn="ctr">
              <a:solidFill>
                <a:schemeClr val="bg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 cap="flat" cmpd="sng" algn="ctr">
                <a:solidFill>
                  <a:schemeClr val="bg1"/>
                </a:solidFill>
                <a:round/>
              </a:ln>
              <a:effectLst/>
            </c:spPr>
          </c:marker>
          <c:trendline>
            <c:spPr>
              <a:ln w="9525" cap="rnd">
                <a:solidFill>
                  <a:schemeClr val="tx1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8744361039321625"/>
                  <c:y val="-1.7977111103659967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dk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Results and graphs'!$B$3:$B$10</c:f>
              <c:numCache>
                <c:formatCode>General</c:formatCode>
                <c:ptCount val="8"/>
                <c:pt idx="0">
                  <c:v>170.4</c:v>
                </c:pt>
                <c:pt idx="1">
                  <c:v>85.2</c:v>
                </c:pt>
                <c:pt idx="2">
                  <c:v>42.6</c:v>
                </c:pt>
                <c:pt idx="3">
                  <c:v>21.3</c:v>
                </c:pt>
                <c:pt idx="4">
                  <c:v>10.65</c:v>
                </c:pt>
                <c:pt idx="5">
                  <c:v>5.3250000000000002</c:v>
                </c:pt>
                <c:pt idx="6">
                  <c:v>2.6625000000000001</c:v>
                </c:pt>
                <c:pt idx="7">
                  <c:v>1.33125</c:v>
                </c:pt>
              </c:numCache>
            </c:numRef>
          </c:xVal>
          <c:yVal>
            <c:numRef>
              <c:f>'Results and graphs'!$C$3:$C$10</c:f>
              <c:numCache>
                <c:formatCode>General</c:formatCode>
                <c:ptCount val="8"/>
                <c:pt idx="0">
                  <c:v>560</c:v>
                </c:pt>
                <c:pt idx="1">
                  <c:v>232</c:v>
                </c:pt>
                <c:pt idx="2">
                  <c:v>122</c:v>
                </c:pt>
                <c:pt idx="3">
                  <c:v>52</c:v>
                </c:pt>
                <c:pt idx="4">
                  <c:v>30</c:v>
                </c:pt>
                <c:pt idx="5">
                  <c:v>10.6</c:v>
                </c:pt>
                <c:pt idx="6">
                  <c:v>4.4000000000000004</c:v>
                </c:pt>
                <c:pt idx="7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F48-42F1-BF1C-330C2F1E417E}"/>
            </c:ext>
          </c:extLst>
        </c:ser>
        <c:ser>
          <c:idx val="1"/>
          <c:order val="1"/>
          <c:tx>
            <c:strRef>
              <c:f>'Results and graphs'!$D$2</c:f>
              <c:strCache>
                <c:ptCount val="1"/>
              </c:strCache>
            </c:strRef>
          </c:tx>
          <c:spPr>
            <a:ln w="25400" cap="flat" cmpd="sng" algn="ctr">
              <a:noFill/>
              <a:prstDash val="sysDot"/>
              <a:round/>
            </a:ln>
            <a:effectLst/>
          </c:spPr>
          <c:marker>
            <c:symbol val="circle"/>
            <c:size val="5"/>
            <c:spPr>
              <a:gradFill rotWithShape="1">
                <a:gsLst>
                  <a:gs pos="0">
                    <a:schemeClr val="accent2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2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2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9525" cap="flat" cmpd="sng" algn="ctr">
                <a:solidFill>
                  <a:schemeClr val="accent2">
                    <a:shade val="95000"/>
                  </a:schemeClr>
                </a:solidFill>
                <a:round/>
              </a:ln>
              <a:effectLst/>
            </c:spPr>
          </c:marker>
          <c:trendline>
            <c:spPr>
              <a:ln w="9525" cap="rnd">
                <a:solidFill>
                  <a:schemeClr val="accent2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4.7835739282589676E-2"/>
                  <c:y val="0.3018452901720618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dk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Results and graphs'!$B$3:$B$10</c:f>
              <c:numCache>
                <c:formatCode>General</c:formatCode>
                <c:ptCount val="8"/>
                <c:pt idx="0">
                  <c:v>170.4</c:v>
                </c:pt>
                <c:pt idx="1">
                  <c:v>85.2</c:v>
                </c:pt>
                <c:pt idx="2">
                  <c:v>42.6</c:v>
                </c:pt>
                <c:pt idx="3">
                  <c:v>21.3</c:v>
                </c:pt>
                <c:pt idx="4">
                  <c:v>10.65</c:v>
                </c:pt>
                <c:pt idx="5">
                  <c:v>5.3250000000000002</c:v>
                </c:pt>
                <c:pt idx="6">
                  <c:v>2.6625000000000001</c:v>
                </c:pt>
                <c:pt idx="7">
                  <c:v>1.33125</c:v>
                </c:pt>
              </c:numCache>
            </c:numRef>
          </c:xVal>
          <c:yVal>
            <c:numRef>
              <c:f>'Results and graphs'!$D$3:$D$10</c:f>
              <c:numCache>
                <c:formatCode>General</c:formatCode>
                <c:ptCount val="8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F48-42F1-BF1C-330C2F1E41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1922568"/>
        <c:axId val="431924920"/>
      </c:scatterChart>
      <c:valAx>
        <c:axId val="4319225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dirty="0"/>
                  <a:t>Input RNA (n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924920"/>
        <c:crosses val="autoZero"/>
        <c:crossBetween val="midCat"/>
      </c:valAx>
      <c:valAx>
        <c:axId val="431924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i="1" dirty="0"/>
                  <a:t>SNORD116 </a:t>
                </a:r>
              </a:p>
              <a:p>
                <a:pPr>
                  <a:defRPr/>
                </a:pPr>
                <a:r>
                  <a:rPr lang="en-AU" dirty="0"/>
                  <a:t>Observed</a:t>
                </a:r>
                <a:r>
                  <a:rPr lang="en-AU" baseline="0" dirty="0"/>
                  <a:t> c</a:t>
                </a:r>
                <a:r>
                  <a:rPr lang="en-AU" dirty="0"/>
                  <a:t>opy number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922568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esults and graphs'!$E$2</c:f>
              <c:strCache>
                <c:ptCount val="1"/>
                <c:pt idx="0">
                  <c:v>UBE3A</c:v>
                </c:pt>
              </c:strCache>
            </c:strRef>
          </c:tx>
          <c:spPr>
            <a:ln w="25400" cap="flat" cmpd="sng" algn="ctr">
              <a:solidFill>
                <a:schemeClr val="bg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 cap="flat" cmpd="sng" algn="ctr">
                <a:solidFill>
                  <a:schemeClr val="bg1"/>
                </a:solidFill>
                <a:round/>
              </a:ln>
              <a:effectLst/>
            </c:spPr>
          </c:marker>
          <c:trendline>
            <c:spPr>
              <a:ln w="9525" cap="rnd">
                <a:solidFill>
                  <a:schemeClr val="accent1"/>
                </a:solidFill>
              </a:ln>
              <a:effectLst/>
            </c:spPr>
            <c:trendlineType val="linear"/>
            <c:dispRSqr val="0"/>
            <c:dispEq val="0"/>
          </c:trendline>
          <c:trendline>
            <c:spPr>
              <a:ln w="9525" cap="rnd">
                <a:solidFill>
                  <a:schemeClr val="accent1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5813778049263003"/>
                  <c:y val="1.366752748045419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dk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9525" cap="rnd">
                <a:solidFill>
                  <a:schemeClr val="tx1"/>
                </a:solidFill>
              </a:ln>
              <a:effectLst/>
            </c:spPr>
            <c:trendlineType val="linear"/>
            <c:dispRSqr val="0"/>
            <c:dispEq val="0"/>
          </c:trendline>
          <c:xVal>
            <c:numRef>
              <c:f>'Results and graphs'!$B$3:$B$10</c:f>
              <c:numCache>
                <c:formatCode>General</c:formatCode>
                <c:ptCount val="8"/>
                <c:pt idx="0">
                  <c:v>170.4</c:v>
                </c:pt>
                <c:pt idx="1">
                  <c:v>85.2</c:v>
                </c:pt>
                <c:pt idx="2">
                  <c:v>42.6</c:v>
                </c:pt>
                <c:pt idx="3">
                  <c:v>21.3</c:v>
                </c:pt>
                <c:pt idx="4">
                  <c:v>10.65</c:v>
                </c:pt>
                <c:pt idx="5">
                  <c:v>5.3250000000000002</c:v>
                </c:pt>
                <c:pt idx="6">
                  <c:v>2.6625000000000001</c:v>
                </c:pt>
                <c:pt idx="7">
                  <c:v>1.33125</c:v>
                </c:pt>
              </c:numCache>
            </c:numRef>
          </c:xVal>
          <c:yVal>
            <c:numRef>
              <c:f>'Results and graphs'!$E$3:$E$10</c:f>
              <c:numCache>
                <c:formatCode>General</c:formatCode>
                <c:ptCount val="8"/>
                <c:pt idx="0">
                  <c:v>3280</c:v>
                </c:pt>
                <c:pt idx="1">
                  <c:v>1340</c:v>
                </c:pt>
                <c:pt idx="2">
                  <c:v>632</c:v>
                </c:pt>
                <c:pt idx="3">
                  <c:v>332</c:v>
                </c:pt>
                <c:pt idx="4">
                  <c:v>144</c:v>
                </c:pt>
                <c:pt idx="5">
                  <c:v>60</c:v>
                </c:pt>
                <c:pt idx="6">
                  <c:v>12.8</c:v>
                </c:pt>
                <c:pt idx="7">
                  <c:v>7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31A-4C7C-8241-C0B82B564BA8}"/>
            </c:ext>
          </c:extLst>
        </c:ser>
        <c:ser>
          <c:idx val="1"/>
          <c:order val="1"/>
          <c:tx>
            <c:strRef>
              <c:f>'Results and graphs'!$F$2</c:f>
              <c:strCache>
                <c:ptCount val="1"/>
              </c:strCache>
            </c:strRef>
          </c:tx>
          <c:spPr>
            <a:ln w="25400" cap="flat" cmpd="sng" algn="ctr">
              <a:noFill/>
              <a:prstDash val="sysDot"/>
              <a:round/>
            </a:ln>
            <a:effectLst/>
          </c:spPr>
          <c:marker>
            <c:symbol val="circle"/>
            <c:size val="5"/>
            <c:spPr>
              <a:gradFill rotWithShape="1">
                <a:gsLst>
                  <a:gs pos="0">
                    <a:schemeClr val="accent2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2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2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9525" cap="flat" cmpd="sng" algn="ctr">
                <a:solidFill>
                  <a:schemeClr val="accent2">
                    <a:shade val="95000"/>
                  </a:schemeClr>
                </a:solidFill>
                <a:round/>
              </a:ln>
              <a:effectLst/>
            </c:spPr>
          </c:marker>
          <c:trendline>
            <c:spPr>
              <a:ln w="9525" cap="rnd">
                <a:solidFill>
                  <a:schemeClr val="accent2"/>
                </a:solidFill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45072968052773738"/>
                  <c:y val="4.9735284373560271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dk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Results and graphs'!$B$3:$B$10</c:f>
              <c:numCache>
                <c:formatCode>General</c:formatCode>
                <c:ptCount val="8"/>
                <c:pt idx="0">
                  <c:v>170.4</c:v>
                </c:pt>
                <c:pt idx="1">
                  <c:v>85.2</c:v>
                </c:pt>
                <c:pt idx="2">
                  <c:v>42.6</c:v>
                </c:pt>
                <c:pt idx="3">
                  <c:v>21.3</c:v>
                </c:pt>
                <c:pt idx="4">
                  <c:v>10.65</c:v>
                </c:pt>
                <c:pt idx="5">
                  <c:v>5.3250000000000002</c:v>
                </c:pt>
                <c:pt idx="6">
                  <c:v>2.6625000000000001</c:v>
                </c:pt>
                <c:pt idx="7">
                  <c:v>1.33125</c:v>
                </c:pt>
              </c:numCache>
            </c:numRef>
          </c:xVal>
          <c:yVal>
            <c:numRef>
              <c:f>'Results and graphs'!$F$3:$F$10</c:f>
              <c:numCache>
                <c:formatCode>General</c:formatCode>
                <c:ptCount val="8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31A-4C7C-8241-C0B82B564B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1924528"/>
        <c:axId val="431925312"/>
      </c:scatterChart>
      <c:valAx>
        <c:axId val="4319245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/>
                  <a:t>Input RNA (n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925312"/>
        <c:crosses val="autoZero"/>
        <c:crossBetween val="midCat"/>
      </c:valAx>
      <c:valAx>
        <c:axId val="431925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i="1" dirty="0"/>
                  <a:t>UBE3A</a:t>
                </a:r>
                <a:r>
                  <a:rPr lang="en-AU" baseline="0" dirty="0"/>
                  <a:t> </a:t>
                </a:r>
              </a:p>
              <a:p>
                <a:pPr>
                  <a:defRPr/>
                </a:pPr>
                <a:r>
                  <a:rPr lang="en-AU" dirty="0"/>
                  <a:t>Observed copy numbers</a:t>
                </a:r>
              </a:p>
            </c:rich>
          </c:tx>
          <c:layout>
            <c:manualLayout>
              <c:xMode val="edge"/>
              <c:yMode val="edge"/>
              <c:x val="1.4479353240353843E-2"/>
              <c:y val="0.11167604900822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924528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/>
    <cs:effectRef idx="1"/>
    <cs:fontRef idx="minor">
      <a:schemeClr val="dk1"/>
    </cs:fontRef>
    <cs:spPr>
      <a:ln w="9525" cap="flat" cmpd="sng" algn="ctr">
        <a:solidFill>
          <a:schemeClr val="phClr">
            <a:alpha val="70000"/>
          </a:schemeClr>
        </a:solidFill>
        <a:prstDash val="sysDot"/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rnd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0" baseline="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>
              <a:alpha val="0"/>
            </a:schemeClr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5000"/>
            <a:lumOff val="75000"/>
          </a:schemeClr>
        </a:solidFill>
        <a:round/>
      </a:ln>
    </cs:spPr>
    <cs:defRPr sz="900" kern="1200" spc="0" baseline="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/>
    <cs:effectRef idx="1"/>
    <cs:fontRef idx="minor">
      <a:schemeClr val="dk1"/>
    </cs:fontRef>
    <cs:spPr>
      <a:ln w="9525" cap="flat" cmpd="sng" algn="ctr">
        <a:solidFill>
          <a:schemeClr val="phClr">
            <a:alpha val="70000"/>
          </a:schemeClr>
        </a:solidFill>
        <a:prstDash val="sysDot"/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rnd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0" baseline="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>
              <a:alpha val="0"/>
            </a:schemeClr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5000"/>
            <a:lumOff val="75000"/>
          </a:schemeClr>
        </a:solidFill>
        <a:round/>
      </a:ln>
    </cs:spPr>
    <cs:defRPr sz="900" kern="1200" spc="0" baseline="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96B47-7687-4D3C-ADA8-84FFB24F75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C63FB8-7CD2-4695-9C96-4DF7EA81D7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46038-EDC8-4BE9-BC73-EB705F844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DFBF3B-29D2-47C0-965F-2293B90E4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892693-EC8A-4826-9A6A-9A9AD4E1F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4685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6EE05-96BC-4039-B19E-3C39DC160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C32377-8A24-48AE-AD22-DE50901430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9F25BB-CD9D-4740-A8B1-5ED596488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58AED8-C021-452D-9326-B2E7FCE2A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0207F5-5894-4338-8906-BCC25C3B4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5927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B6CE96-2A6D-4B6B-A317-BF35BC209B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4F5417-E580-4D7D-BE45-6647B51404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AB25A1-F5B0-4EE4-954F-1F81B3A0D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78AA3C-4E18-4669-80F5-99ADEE726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9E082-2579-455E-9632-0ED784496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2069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6D5444-3CCC-4EF8-A0D3-16BA0F672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87BDED-DE2E-4764-AC0E-B899D1C1B5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9273B0-093C-4A04-AF75-5F5F8B4C0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EDCAF1-21E0-496F-8B68-B54DF789B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FA9EE3-8119-4A6A-8E2C-149FB9465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21782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56E78-2252-453E-941E-CE9D97B06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DB68F6-FB3A-4E09-BBB0-A90F7E3B57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760555-49D9-4EC4-89E4-799213F37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D255A6-8DF8-4DF3-8407-20B654BE4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69D87-23D3-4A61-B3F5-9A83100716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530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B42F71-9E0F-43C6-8C27-300B6AB1FA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939361-497E-431D-8599-CEEDBF4D08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FAB04C-88DA-4AD4-8023-D3B559B58B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DFD82F-E1D4-49A7-8177-F634325E1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7F6FA3-EA7E-49CB-9023-AD137E092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0D1D23-F737-4516-B498-04C3F385F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6340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8AC5C-0B34-4BD3-AA64-DD25D8B33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8EEC59-F01B-4C7E-A119-6FCF3D24CC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1C0950-F886-467C-B476-AEC3F8C94A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E21507-12BE-485C-A450-54F06D76A0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82D001-82AE-428D-9F09-9C697F35EF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45230F-093C-4DC2-9BB6-9A1E84636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425906-C886-4022-9E1E-E9646CE69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363F76-5F7D-4DF8-9D35-EE78495D4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17330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5424E-1626-4023-B76B-AFEC4BA9F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292F1B-3057-4F4C-BC3A-20409AEC7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5E235F-027F-49E4-8EA4-FA29A5D6E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360F49-0EA2-4AA1-B18E-67BF1A604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1740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667769-AAC8-46AD-8B64-BE82F2E16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9A6648-904F-40E5-BDE8-854087560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CFD0A1-FE56-4D47-8223-17BD64A30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7042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CC61C-B06B-47A6-9D69-C69F494E2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E6D622-A85D-4552-9548-0C5C6E6B98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467C58-69B4-4116-9145-EA443A7A33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5FFA44-CFA6-469E-8BD4-86A9B1A53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FB5649-7798-4546-9428-563C5F8BA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4817B0-9A6A-4485-80CE-7F4DE70B2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0528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4F98AB-C5A2-4BD2-91B9-EC14AB305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F7B22F-34F7-497B-992B-616BB45474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B480CC-50CD-4D80-A45A-E80A4751DE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7C81C4-0AA7-4D5C-A802-000E23152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A21AF3-1F2C-4487-B499-4DEBABB3C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23F1D8-9476-4E67-8F1C-0ADB34C99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41426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446C0A-75D3-4CB4-AD15-9F832200A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A9EC57-497D-4842-9F1F-C67FF595E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F8222D-3D15-488B-BAB4-2BCA0CA9CC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A3DBE-C91A-43FF-B086-1A1A17F0D701}" type="datetimeFigureOut">
              <a:rPr lang="en-AU" smtClean="0"/>
              <a:t>18/09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E34A9-B852-425A-B32A-5C038C1E1A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D8603-0E55-4A7C-AEBB-7712871227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E91D7-55FD-4DEC-A22B-683881E5B79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5740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54BDAB9-E1E4-4B21-B395-BCFA42E3CB59}"/>
              </a:ext>
            </a:extLst>
          </p:cNvPr>
          <p:cNvSpPr/>
          <p:nvPr/>
        </p:nvSpPr>
        <p:spPr>
          <a:xfrm>
            <a:off x="-61898" y="-71289"/>
            <a:ext cx="112883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. </a:t>
            </a:r>
            <a:endParaRPr kumimoji="0" lang="en-AU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258" y="530679"/>
            <a:ext cx="3641378" cy="312705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293" y="3606108"/>
            <a:ext cx="3659307" cy="3088620"/>
          </a:xfrm>
          <a:prstGeom prst="rect">
            <a:avLst/>
          </a:prstGeom>
        </p:spPr>
      </p:pic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4028140" y="715702"/>
          <a:ext cx="2854350" cy="268858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33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75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33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968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 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RNA input amount(ng)*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i="1" u="none" strike="noStrike" dirty="0">
                          <a:effectLst/>
                        </a:rPr>
                        <a:t>SNRPN </a:t>
                      </a:r>
                      <a:r>
                        <a:rPr lang="en-AU" sz="1100" i="0" u="none" strike="noStrike" dirty="0">
                          <a:effectLst/>
                        </a:rPr>
                        <a:t>observed copy number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1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70.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560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85.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232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42.6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2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21.3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5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0.6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30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5.325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10.6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7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2.662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4.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2017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8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.3312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0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/>
        </p:nvGraphicFramePr>
        <p:xfrm>
          <a:off x="7444277" y="813333"/>
          <a:ext cx="3565595" cy="26245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4034115" y="3783787"/>
          <a:ext cx="2854350" cy="261038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33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75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133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9914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 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RNA input amount(ng)*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i="1" u="none" strike="noStrike" dirty="0">
                          <a:effectLst/>
                        </a:rPr>
                        <a:t>UBE3A</a:t>
                      </a:r>
                      <a:r>
                        <a:rPr lang="en-AU" sz="1100" u="none" strike="noStrike" dirty="0">
                          <a:effectLst/>
                        </a:rPr>
                        <a:t> observed copy number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1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170.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3280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85.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340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42.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63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21.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33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0.6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4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5.32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60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7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2.662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12.8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2243"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ST8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>
                          <a:effectLst/>
                        </a:rPr>
                        <a:t>1.3312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u="none" strike="noStrike" dirty="0">
                          <a:effectLst/>
                        </a:rPr>
                        <a:t>7.8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/>
        </p:nvGraphicFramePr>
        <p:xfrm>
          <a:off x="7567596" y="3868828"/>
          <a:ext cx="3573757" cy="2647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853EBDF-9C80-4C1A-9F3A-56424E932A22}"/>
              </a:ext>
            </a:extLst>
          </p:cNvPr>
          <p:cNvSpPr txBox="1"/>
          <p:nvPr/>
        </p:nvSpPr>
        <p:spPr>
          <a:xfrm>
            <a:off x="181684" y="600906"/>
            <a:ext cx="4268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.</a:t>
            </a:r>
            <a:endParaRPr kumimoji="0" lang="en-AU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53EBDF-9C80-4C1A-9F3A-56424E932A22}"/>
              </a:ext>
            </a:extLst>
          </p:cNvPr>
          <p:cNvSpPr txBox="1"/>
          <p:nvPr/>
        </p:nvSpPr>
        <p:spPr>
          <a:xfrm>
            <a:off x="181684" y="3606108"/>
            <a:ext cx="4268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.</a:t>
            </a:r>
            <a:endParaRPr kumimoji="0" lang="en-AU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Arrow: Down 23">
            <a:extLst>
              <a:ext uri="{FF2B5EF4-FFF2-40B4-BE49-F238E27FC236}">
                <a16:creationId xmlns:a16="http://schemas.microsoft.com/office/drawing/2014/main" id="{F25D7FFB-028A-4328-BC83-B0CB723E7468}"/>
              </a:ext>
            </a:extLst>
          </p:cNvPr>
          <p:cNvSpPr/>
          <p:nvPr/>
        </p:nvSpPr>
        <p:spPr>
          <a:xfrm rot="5400000">
            <a:off x="6909794" y="2873782"/>
            <a:ext cx="216024" cy="26857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U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Arrow: Down 24">
            <a:extLst>
              <a:ext uri="{FF2B5EF4-FFF2-40B4-BE49-F238E27FC236}">
                <a16:creationId xmlns:a16="http://schemas.microsoft.com/office/drawing/2014/main" id="{385E31FE-D281-49CA-B14D-588F70271923}"/>
              </a:ext>
            </a:extLst>
          </p:cNvPr>
          <p:cNvSpPr/>
          <p:nvPr/>
        </p:nvSpPr>
        <p:spPr>
          <a:xfrm rot="5400000">
            <a:off x="6908766" y="1261079"/>
            <a:ext cx="216024" cy="26857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U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Arrow: Down 23">
            <a:extLst>
              <a:ext uri="{FF2B5EF4-FFF2-40B4-BE49-F238E27FC236}">
                <a16:creationId xmlns:a16="http://schemas.microsoft.com/office/drawing/2014/main" id="{F25D7FFB-028A-4328-BC83-B0CB723E7468}"/>
              </a:ext>
            </a:extLst>
          </p:cNvPr>
          <p:cNvSpPr/>
          <p:nvPr/>
        </p:nvSpPr>
        <p:spPr>
          <a:xfrm rot="5400000">
            <a:off x="6908766" y="6071646"/>
            <a:ext cx="216024" cy="26857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U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Arrow: Down 24">
            <a:extLst>
              <a:ext uri="{FF2B5EF4-FFF2-40B4-BE49-F238E27FC236}">
                <a16:creationId xmlns:a16="http://schemas.microsoft.com/office/drawing/2014/main" id="{385E31FE-D281-49CA-B14D-588F70271923}"/>
              </a:ext>
            </a:extLst>
          </p:cNvPr>
          <p:cNvSpPr/>
          <p:nvPr/>
        </p:nvSpPr>
        <p:spPr>
          <a:xfrm rot="5400000">
            <a:off x="6907738" y="4327466"/>
            <a:ext cx="216024" cy="268576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AU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7320217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BAKER</dc:creator>
  <cp:lastModifiedBy>EMMA BAKER</cp:lastModifiedBy>
  <cp:revision>1</cp:revision>
  <dcterms:created xsi:type="dcterms:W3CDTF">2020-09-18T07:03:59Z</dcterms:created>
  <dcterms:modified xsi:type="dcterms:W3CDTF">2020-09-18T07:04:18Z</dcterms:modified>
</cp:coreProperties>
</file>